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77" d="100"/>
          <a:sy n="77" d="100"/>
        </p:scale>
        <p:origin x="120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24C5F-18C4-4361-8116-C3091C949540}" type="datetimeFigureOut">
              <a:rPr lang="de-DE" smtClean="0"/>
              <a:t>12.11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F7DC3-1F40-44B9-9DEB-7C8ACB5013D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389452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24C5F-18C4-4361-8116-C3091C949540}" type="datetimeFigureOut">
              <a:rPr lang="de-DE" smtClean="0"/>
              <a:t>12.11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F7DC3-1F40-44B9-9DEB-7C8ACB5013D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241542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24C5F-18C4-4361-8116-C3091C949540}" type="datetimeFigureOut">
              <a:rPr lang="de-DE" smtClean="0"/>
              <a:t>12.11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F7DC3-1F40-44B9-9DEB-7C8ACB5013D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646318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24C5F-18C4-4361-8116-C3091C949540}" type="datetimeFigureOut">
              <a:rPr lang="de-DE" smtClean="0"/>
              <a:t>12.11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F7DC3-1F40-44B9-9DEB-7C8ACB5013D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782765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24C5F-18C4-4361-8116-C3091C949540}" type="datetimeFigureOut">
              <a:rPr lang="de-DE" smtClean="0"/>
              <a:t>12.11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F7DC3-1F40-44B9-9DEB-7C8ACB5013D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763070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24C5F-18C4-4361-8116-C3091C949540}" type="datetimeFigureOut">
              <a:rPr lang="de-DE" smtClean="0"/>
              <a:t>12.11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F7DC3-1F40-44B9-9DEB-7C8ACB5013D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764454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24C5F-18C4-4361-8116-C3091C949540}" type="datetimeFigureOut">
              <a:rPr lang="de-DE" smtClean="0"/>
              <a:t>12.11.2021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F7DC3-1F40-44B9-9DEB-7C8ACB5013D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00458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24C5F-18C4-4361-8116-C3091C949540}" type="datetimeFigureOut">
              <a:rPr lang="de-DE" smtClean="0"/>
              <a:t>12.11.2021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F7DC3-1F40-44B9-9DEB-7C8ACB5013D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048417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24C5F-18C4-4361-8116-C3091C949540}" type="datetimeFigureOut">
              <a:rPr lang="de-DE" smtClean="0"/>
              <a:t>12.11.2021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F7DC3-1F40-44B9-9DEB-7C8ACB5013D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485320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24C5F-18C4-4361-8116-C3091C949540}" type="datetimeFigureOut">
              <a:rPr lang="de-DE" smtClean="0"/>
              <a:t>12.11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F7DC3-1F40-44B9-9DEB-7C8ACB5013D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346042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24C5F-18C4-4361-8116-C3091C949540}" type="datetimeFigureOut">
              <a:rPr lang="de-DE" smtClean="0"/>
              <a:t>12.11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F7DC3-1F40-44B9-9DEB-7C8ACB5013D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16173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324C5F-18C4-4361-8116-C3091C949540}" type="datetimeFigureOut">
              <a:rPr lang="de-DE" smtClean="0"/>
              <a:t>12.11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CF7DC3-1F40-44B9-9DEB-7C8ACB5013D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780018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06112" y="898871"/>
            <a:ext cx="7575814" cy="4335088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3345356" y="282175"/>
            <a:ext cx="535873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de-DE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2000" b="1" dirty="0"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  <a:r>
              <a:rPr lang="de-DE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        </a:t>
            </a:r>
            <a:r>
              <a:rPr lang="de-DE" sz="2000" b="1" dirty="0">
                <a:latin typeface="Arial" panose="020B0604020202020204" pitchFamily="34" charset="0"/>
                <a:cs typeface="Arial" panose="020B0604020202020204" pitchFamily="34" charset="0"/>
              </a:rPr>
              <a:t>p=0.3</a:t>
            </a:r>
          </a:p>
        </p:txBody>
      </p:sp>
      <p:sp>
        <p:nvSpPr>
          <p:cNvPr id="3" name="Rechteck 2"/>
          <p:cNvSpPr/>
          <p:nvPr/>
        </p:nvSpPr>
        <p:spPr>
          <a:xfrm>
            <a:off x="185701" y="6387655"/>
            <a:ext cx="1142592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smtClean="0"/>
              <a:t>Supplemental figure 1: Pattern </a:t>
            </a:r>
            <a:r>
              <a:rPr lang="en-US" dirty="0"/>
              <a:t>of primary method of estimation did not differ relevantly between CIED types (p=0.3).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7183511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3345356" y="282175"/>
            <a:ext cx="535873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de-DE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2000" b="1" dirty="0"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  <a:r>
              <a:rPr lang="de-DE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        </a:t>
            </a:r>
            <a:r>
              <a:rPr lang="de-DE" sz="2000" b="1" dirty="0">
                <a:latin typeface="Arial" panose="020B0604020202020204" pitchFamily="34" charset="0"/>
                <a:cs typeface="Arial" panose="020B0604020202020204" pitchFamily="34" charset="0"/>
              </a:rPr>
              <a:t>p=0.4</a:t>
            </a:r>
          </a:p>
        </p:txBody>
      </p:sp>
      <p:pic>
        <p:nvPicPr>
          <p:cNvPr id="7" name="Grafik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02124" y="790724"/>
            <a:ext cx="5352752" cy="5352752"/>
          </a:xfrm>
          <a:prstGeom prst="rect">
            <a:avLst/>
          </a:prstGeom>
        </p:spPr>
      </p:pic>
      <p:sp>
        <p:nvSpPr>
          <p:cNvPr id="2" name="Rechteck 1"/>
          <p:cNvSpPr/>
          <p:nvPr/>
        </p:nvSpPr>
        <p:spPr>
          <a:xfrm>
            <a:off x="0" y="5934670"/>
            <a:ext cx="1219200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GB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2: </a:t>
            </a:r>
            <a:r>
              <a:rPr lang="en-GB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ox </a:t>
            </a:r>
            <a:r>
              <a:rPr lang="en-GB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lots depict mean and IQR of time between autopsy and CIED interrogation in group comparison (no estimation possible vs. estimation possible). The numerical difference is not statistically significant (p=0.4). </a:t>
            </a:r>
            <a:endParaRPr lang="de-DE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26784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Inhaltsplatzhalt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699906697"/>
              </p:ext>
            </p:extLst>
          </p:nvPr>
        </p:nvGraphicFramePr>
        <p:xfrm>
          <a:off x="136099" y="812969"/>
          <a:ext cx="11811240" cy="3277698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984270">
                  <a:extLst>
                    <a:ext uri="{9D8B030D-6E8A-4147-A177-3AD203B41FA5}">
                      <a16:colId xmlns:a16="http://schemas.microsoft.com/office/drawing/2014/main" val="1231878686"/>
                    </a:ext>
                  </a:extLst>
                </a:gridCol>
                <a:gridCol w="984270">
                  <a:extLst>
                    <a:ext uri="{9D8B030D-6E8A-4147-A177-3AD203B41FA5}">
                      <a16:colId xmlns:a16="http://schemas.microsoft.com/office/drawing/2014/main" val="3266035765"/>
                    </a:ext>
                  </a:extLst>
                </a:gridCol>
                <a:gridCol w="984270">
                  <a:extLst>
                    <a:ext uri="{9D8B030D-6E8A-4147-A177-3AD203B41FA5}">
                      <a16:colId xmlns:a16="http://schemas.microsoft.com/office/drawing/2014/main" val="3909102765"/>
                    </a:ext>
                  </a:extLst>
                </a:gridCol>
                <a:gridCol w="984270">
                  <a:extLst>
                    <a:ext uri="{9D8B030D-6E8A-4147-A177-3AD203B41FA5}">
                      <a16:colId xmlns:a16="http://schemas.microsoft.com/office/drawing/2014/main" val="2578612452"/>
                    </a:ext>
                  </a:extLst>
                </a:gridCol>
                <a:gridCol w="984270">
                  <a:extLst>
                    <a:ext uri="{9D8B030D-6E8A-4147-A177-3AD203B41FA5}">
                      <a16:colId xmlns:a16="http://schemas.microsoft.com/office/drawing/2014/main" val="3411074801"/>
                    </a:ext>
                  </a:extLst>
                </a:gridCol>
                <a:gridCol w="984270">
                  <a:extLst>
                    <a:ext uri="{9D8B030D-6E8A-4147-A177-3AD203B41FA5}">
                      <a16:colId xmlns:a16="http://schemas.microsoft.com/office/drawing/2014/main" val="2057180390"/>
                    </a:ext>
                  </a:extLst>
                </a:gridCol>
                <a:gridCol w="984270">
                  <a:extLst>
                    <a:ext uri="{9D8B030D-6E8A-4147-A177-3AD203B41FA5}">
                      <a16:colId xmlns:a16="http://schemas.microsoft.com/office/drawing/2014/main" val="1111787065"/>
                    </a:ext>
                  </a:extLst>
                </a:gridCol>
                <a:gridCol w="984270">
                  <a:extLst>
                    <a:ext uri="{9D8B030D-6E8A-4147-A177-3AD203B41FA5}">
                      <a16:colId xmlns:a16="http://schemas.microsoft.com/office/drawing/2014/main" val="2287666159"/>
                    </a:ext>
                  </a:extLst>
                </a:gridCol>
                <a:gridCol w="984270">
                  <a:extLst>
                    <a:ext uri="{9D8B030D-6E8A-4147-A177-3AD203B41FA5}">
                      <a16:colId xmlns:a16="http://schemas.microsoft.com/office/drawing/2014/main" val="3515821077"/>
                    </a:ext>
                  </a:extLst>
                </a:gridCol>
                <a:gridCol w="984270">
                  <a:extLst>
                    <a:ext uri="{9D8B030D-6E8A-4147-A177-3AD203B41FA5}">
                      <a16:colId xmlns:a16="http://schemas.microsoft.com/office/drawing/2014/main" val="3694566515"/>
                    </a:ext>
                  </a:extLst>
                </a:gridCol>
                <a:gridCol w="984270">
                  <a:extLst>
                    <a:ext uri="{9D8B030D-6E8A-4147-A177-3AD203B41FA5}">
                      <a16:colId xmlns:a16="http://schemas.microsoft.com/office/drawing/2014/main" val="2225278273"/>
                    </a:ext>
                  </a:extLst>
                </a:gridCol>
                <a:gridCol w="984270">
                  <a:extLst>
                    <a:ext uri="{9D8B030D-6E8A-4147-A177-3AD203B41FA5}">
                      <a16:colId xmlns:a16="http://schemas.microsoft.com/office/drawing/2014/main" val="279149996"/>
                    </a:ext>
                  </a:extLst>
                </a:gridCol>
              </a:tblGrid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</a:rPr>
                        <a:t>ID 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</a:rPr>
                        <a:t> 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</a:rPr>
                        <a:t>Type (0:pm, 1: ICD)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 err="1">
                          <a:effectLst/>
                        </a:rPr>
                        <a:t>number</a:t>
                      </a:r>
                      <a:r>
                        <a:rPr lang="de-DE" sz="1200" u="none" strike="noStrike" dirty="0">
                          <a:effectLst/>
                        </a:rPr>
                        <a:t> of </a:t>
                      </a:r>
                      <a:r>
                        <a:rPr lang="de-DE" sz="1200" u="none" strike="noStrike" dirty="0" err="1">
                          <a:effectLst/>
                        </a:rPr>
                        <a:t>leads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manufacture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 err="1">
                          <a:effectLst/>
                        </a:rPr>
                        <a:t>model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 err="1">
                          <a:effectLst/>
                        </a:rPr>
                        <a:t>battery</a:t>
                      </a:r>
                      <a:r>
                        <a:rPr lang="de-DE" sz="1200" u="none" strike="noStrike" dirty="0">
                          <a:effectLst/>
                        </a:rPr>
                        <a:t> </a:t>
                      </a:r>
                      <a:r>
                        <a:rPr lang="de-DE" sz="1200" u="none" strike="noStrike" dirty="0" err="1">
                          <a:effectLst/>
                        </a:rPr>
                        <a:t>intact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</a:rPr>
                        <a:t>CIED </a:t>
                      </a:r>
                      <a:r>
                        <a:rPr lang="de-DE" sz="1200" u="none" strike="noStrike" dirty="0" err="1">
                          <a:effectLst/>
                        </a:rPr>
                        <a:t>active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 err="1">
                          <a:effectLst/>
                        </a:rPr>
                        <a:t>estimation</a:t>
                      </a:r>
                      <a:r>
                        <a:rPr lang="de-DE" sz="1200" u="none" strike="noStrike" dirty="0">
                          <a:effectLst/>
                        </a:rPr>
                        <a:t> </a:t>
                      </a:r>
                      <a:r>
                        <a:rPr lang="de-DE" sz="1200" u="none" strike="noStrike" dirty="0" err="1">
                          <a:effectLst/>
                        </a:rPr>
                        <a:t>possible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 err="1">
                          <a:effectLst/>
                        </a:rPr>
                        <a:t>hours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 err="1">
                          <a:effectLst/>
                        </a:rPr>
                        <a:t>days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 err="1">
                          <a:effectLst/>
                        </a:rPr>
                        <a:t>method</a:t>
                      </a:r>
                      <a:r>
                        <a:rPr lang="de-DE" sz="1200" u="none" strike="noStrike" dirty="0">
                          <a:effectLst/>
                        </a:rPr>
                        <a:t> of </a:t>
                      </a:r>
                      <a:r>
                        <a:rPr lang="de-DE" sz="1200" u="none" strike="noStrike" dirty="0" err="1">
                          <a:effectLst/>
                        </a:rPr>
                        <a:t>estimation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786362437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</a:rPr>
                        <a:t>1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 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</a:rPr>
                        <a:t>1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</a:rPr>
                        <a:t>Medtronic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Relia S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</a:rPr>
                        <a:t>1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 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 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 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831123648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</a:rPr>
                        <a:t>Medtronic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 err="1">
                          <a:effectLst/>
                        </a:rPr>
                        <a:t>Ensura</a:t>
                      </a:r>
                      <a:r>
                        <a:rPr lang="de-DE" sz="1200" u="none" strike="noStrike" dirty="0">
                          <a:effectLst/>
                        </a:rPr>
                        <a:t> DR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</a:rPr>
                        <a:t>pacing threshold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524788772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3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Medtronic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Ensura S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</a:rPr>
                        <a:t>pacing threshold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127709345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4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</a:rPr>
                        <a:t>Medtronic 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Ensura D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</a:rPr>
                        <a:t>arrhythmia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882932226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5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St. Jude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Verity S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</a:rPr>
                        <a:t>pacing threshold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635524321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6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Biotronik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Ecuro D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</a:rPr>
                        <a:t>pacing threshold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85456759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7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Medtronic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Ensura D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</a:rPr>
                        <a:t>pacing threshold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467784699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8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Medtronic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Ensura D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709766506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9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Biotronik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Talos D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</a:rPr>
                        <a:t>1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 err="1">
                          <a:effectLst/>
                        </a:rPr>
                        <a:t>percentage</a:t>
                      </a:r>
                      <a:r>
                        <a:rPr lang="de-DE" sz="1200" u="none" strike="noStrike" dirty="0">
                          <a:effectLst/>
                        </a:rPr>
                        <a:t> of pacing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55543154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Medtronik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Maximo II V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</a:rPr>
                        <a:t>1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</a:rPr>
                        <a:t>arrhythmia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647856279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control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Biotronik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Ecuro D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 err="1">
                          <a:effectLst/>
                        </a:rPr>
                        <a:t>sensing</a:t>
                      </a:r>
                      <a:r>
                        <a:rPr lang="de-DE" sz="1200" u="none" strike="noStrike" dirty="0">
                          <a:effectLst/>
                        </a:rPr>
                        <a:t> trends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290920978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control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St. Jude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Sustain D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910331525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3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control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Medtronic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Relia S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198345747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4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Biotronik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Inlexa 3 DR-T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 err="1">
                          <a:effectLst/>
                        </a:rPr>
                        <a:t>percentage</a:t>
                      </a:r>
                      <a:r>
                        <a:rPr lang="de-DE" sz="1200" u="none" strike="noStrike" dirty="0">
                          <a:effectLst/>
                        </a:rPr>
                        <a:t> of pacing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738504660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5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Biotronik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Ecuro D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 err="1">
                          <a:effectLst/>
                        </a:rPr>
                        <a:t>sensing</a:t>
                      </a:r>
                      <a:r>
                        <a:rPr lang="de-DE" sz="1200" u="none" strike="noStrike" dirty="0">
                          <a:effectLst/>
                        </a:rPr>
                        <a:t> trends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184524820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6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 err="1" smtClean="0">
                          <a:effectLst/>
                        </a:rPr>
                        <a:t>unkown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11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200" u="none" strike="noStrike" dirty="0" err="1" smtClean="0">
                          <a:effectLst/>
                        </a:rPr>
                        <a:t>unkown</a:t>
                      </a:r>
                      <a:endParaRPr lang="de-DE" sz="1200" b="0" i="0" u="none" strike="noStrike" dirty="0" smtClean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218308063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7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control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Medtronic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Sensia D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</a:rPr>
                        <a:t>pacing threshold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40095909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8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control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Biotronik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 err="1">
                          <a:effectLst/>
                        </a:rPr>
                        <a:t>Lumax</a:t>
                      </a:r>
                      <a:r>
                        <a:rPr lang="de-DE" sz="1200" u="none" strike="noStrike" dirty="0">
                          <a:effectLst/>
                        </a:rPr>
                        <a:t> DR-T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 err="1">
                          <a:effectLst/>
                        </a:rPr>
                        <a:t>percentage</a:t>
                      </a:r>
                      <a:r>
                        <a:rPr lang="de-DE" sz="1200" u="none" strike="noStrike" dirty="0">
                          <a:effectLst/>
                        </a:rPr>
                        <a:t> of pacing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519121344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9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3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Medtronic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Protecta CRT-D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062439121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control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Biotronik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Enticos D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 err="1">
                          <a:effectLst/>
                        </a:rPr>
                        <a:t>percentage</a:t>
                      </a:r>
                      <a:r>
                        <a:rPr lang="de-DE" sz="1200" u="none" strike="noStrike" dirty="0">
                          <a:effectLst/>
                        </a:rPr>
                        <a:t> of pacing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423945292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control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Biotronik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Talos D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 err="1">
                          <a:effectLst/>
                        </a:rPr>
                        <a:t>percentage</a:t>
                      </a:r>
                      <a:r>
                        <a:rPr lang="de-DE" sz="1200" u="none" strike="noStrike" dirty="0">
                          <a:effectLst/>
                        </a:rPr>
                        <a:t> of pacing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644379130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Medtronic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Relia D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334913382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3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control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3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Biotronik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Enitra 8 HF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</a:rPr>
                        <a:t>1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 err="1">
                          <a:effectLst/>
                        </a:rPr>
                        <a:t>percentage</a:t>
                      </a:r>
                      <a:r>
                        <a:rPr lang="de-DE" sz="1200" u="none" strike="noStrike" dirty="0">
                          <a:effectLst/>
                        </a:rPr>
                        <a:t> of pacing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009397334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4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Biotronik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Ecuro D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</a:rPr>
                        <a:t>arrhythmia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346942767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5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St. Jude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Endurity  2K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</a:rPr>
                        <a:t>1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additional diagnostics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648198440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6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control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3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Medtronic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Brava Quad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</a:rPr>
                        <a:t>arrhythmia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424283811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7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control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Medtronic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Ensura S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</a:rPr>
                        <a:t>1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 err="1">
                          <a:effectLst/>
                        </a:rPr>
                        <a:t>sensing</a:t>
                      </a:r>
                      <a:r>
                        <a:rPr lang="de-DE" sz="1200" u="none" strike="noStrike" dirty="0">
                          <a:effectLst/>
                        </a:rPr>
                        <a:t> trends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132659073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8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control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Biotronik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Rivacor VR-T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</a:rPr>
                        <a:t>1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</a:rPr>
                        <a:t>pacing threshold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477556850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9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Medtronic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Protecta V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</a:rPr>
                        <a:t>arrhythmia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490896185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3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St. Jude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Verity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716599297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3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control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Biotronik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Effecta S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</a:rPr>
                        <a:t>1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 err="1">
                          <a:effectLst/>
                        </a:rPr>
                        <a:t>sensing</a:t>
                      </a:r>
                      <a:r>
                        <a:rPr lang="de-DE" sz="1200" u="none" strike="noStrike" dirty="0">
                          <a:effectLst/>
                        </a:rPr>
                        <a:t> trends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176243216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3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control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Medtronic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Sensia D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</a:rPr>
                        <a:t>arrhythmia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126911862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33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control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St. Jude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 err="1">
                          <a:effectLst/>
                        </a:rPr>
                        <a:t>Endurity</a:t>
                      </a:r>
                      <a:r>
                        <a:rPr lang="de-DE" sz="1200" u="none" strike="noStrike" dirty="0">
                          <a:effectLst/>
                        </a:rPr>
                        <a:t> Core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4864935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34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Biotronik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Enitra 8 DR-T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 err="1">
                          <a:effectLst/>
                        </a:rPr>
                        <a:t>sensing</a:t>
                      </a:r>
                      <a:r>
                        <a:rPr lang="de-DE" sz="1200" u="none" strike="noStrike" dirty="0">
                          <a:effectLst/>
                        </a:rPr>
                        <a:t> trends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717523674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35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Medtronic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Protecta V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192647677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36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Vitatron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T70 D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914347593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37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control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St. Jude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Sustain D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023488593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38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control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Medtronic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Relia D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058835893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39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Boston Scientific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smtClean="0">
                          <a:effectLst/>
                        </a:rPr>
                        <a:t>Essentio</a:t>
                      </a:r>
                      <a:r>
                        <a:rPr lang="de-DE" sz="1200" u="none" strike="noStrike" dirty="0" smtClean="0">
                          <a:effectLst/>
                        </a:rPr>
                        <a:t> </a:t>
                      </a:r>
                      <a:r>
                        <a:rPr lang="de-DE" sz="1200" u="none" strike="noStrike" dirty="0">
                          <a:effectLst/>
                        </a:rPr>
                        <a:t>DR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</a:rPr>
                        <a:t>1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</a:rPr>
                        <a:t>arrhythmia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526279426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4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Medtronic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Sensia D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873378432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4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Medtronic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Sensia V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780601984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4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control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3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Boston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Inogen CRT-D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</a:rPr>
                        <a:t>arrhythmia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526781005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43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Medtronic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Ensura D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</a:rPr>
                        <a:t>arrhythmia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787152911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44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3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Biotronik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Entovis HF-T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 err="1">
                          <a:effectLst/>
                        </a:rPr>
                        <a:t>sensing</a:t>
                      </a:r>
                      <a:r>
                        <a:rPr lang="de-DE" sz="1200" u="none" strike="noStrike" dirty="0">
                          <a:effectLst/>
                        </a:rPr>
                        <a:t> trends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889426864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45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Microport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Paradym 2 D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 err="1">
                          <a:effectLst/>
                        </a:rPr>
                        <a:t>percentage</a:t>
                      </a:r>
                      <a:r>
                        <a:rPr lang="de-DE" sz="1200" u="none" strike="noStrike" dirty="0">
                          <a:effectLst/>
                        </a:rPr>
                        <a:t> of pacing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833619125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46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St. Jude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Ellipse D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 err="1">
                          <a:effectLst/>
                        </a:rPr>
                        <a:t>sensing</a:t>
                      </a:r>
                      <a:r>
                        <a:rPr lang="de-DE" sz="1200" u="none" strike="noStrike" dirty="0">
                          <a:effectLst/>
                        </a:rPr>
                        <a:t> trends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570564695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47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Vitatron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T20 S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790243788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48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Biotronik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Iforia 3 VR-T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 err="1">
                          <a:effectLst/>
                        </a:rPr>
                        <a:t>sensing</a:t>
                      </a:r>
                      <a:r>
                        <a:rPr lang="de-DE" sz="1200" u="none" strike="noStrike" dirty="0">
                          <a:effectLst/>
                        </a:rPr>
                        <a:t> trends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608552366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49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Biotronik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Ecuro D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 err="1">
                          <a:effectLst/>
                        </a:rPr>
                        <a:t>percentage</a:t>
                      </a:r>
                      <a:r>
                        <a:rPr lang="de-DE" sz="1200" u="none" strike="noStrike" dirty="0">
                          <a:effectLst/>
                        </a:rPr>
                        <a:t> of pacing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386091842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5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Medtronic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Ensura D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53258768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5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Medtronic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Mirro V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</a:rPr>
                        <a:t>arrhythmia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376667807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5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St. Jude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Sustain D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716127289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53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Medtronic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Astra XT D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</a:rPr>
                        <a:t>pacing threshold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573979016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54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control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Medtronic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Ensura D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</a:rPr>
                        <a:t>pacing threshold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209301265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55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3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Boston Scientific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Inogen CRT-D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</a:rPr>
                        <a:t>arrhythmia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3933769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56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Medtronic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Relia S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652418770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57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control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St. Jude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Sustain D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016640843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58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Biotronik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Enticos 4 D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 err="1">
                          <a:effectLst/>
                        </a:rPr>
                        <a:t>percentage</a:t>
                      </a:r>
                      <a:r>
                        <a:rPr lang="de-DE" sz="1200" u="none" strike="noStrike" dirty="0">
                          <a:effectLst/>
                        </a:rPr>
                        <a:t> of pacing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227562811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59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Biotronik 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Entovis DR-T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 err="1">
                          <a:effectLst/>
                        </a:rPr>
                        <a:t>sensing</a:t>
                      </a:r>
                      <a:r>
                        <a:rPr lang="de-DE" sz="1200" u="none" strike="noStrike" dirty="0">
                          <a:effectLst/>
                        </a:rPr>
                        <a:t> trends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374439318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6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3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Medtronic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Consulta CRT-P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00278122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6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Biotronik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Effecta D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 err="1">
                          <a:effectLst/>
                        </a:rPr>
                        <a:t>percentage</a:t>
                      </a:r>
                      <a:r>
                        <a:rPr lang="de-DE" sz="1200" u="none" strike="noStrike" dirty="0">
                          <a:effectLst/>
                        </a:rPr>
                        <a:t> of pacing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557051647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6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Biotronik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Effecta D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 err="1">
                          <a:effectLst/>
                        </a:rPr>
                        <a:t>percentage</a:t>
                      </a:r>
                      <a:r>
                        <a:rPr lang="de-DE" sz="1200" u="none" strike="noStrike" dirty="0">
                          <a:effectLst/>
                        </a:rPr>
                        <a:t> of pacing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233169864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63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Biotronik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Evia DR-T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 err="1">
                          <a:effectLst/>
                        </a:rPr>
                        <a:t>percentage</a:t>
                      </a:r>
                      <a:r>
                        <a:rPr lang="de-DE" sz="1200" u="none" strike="noStrike" dirty="0">
                          <a:effectLst/>
                        </a:rPr>
                        <a:t> of pacing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454445268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64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 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Medtronic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Ensura D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 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 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 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681140370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65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Medtronic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Relia S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932732820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66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3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Medtronic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Amplia Quad CRT-D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</a:rPr>
                        <a:t>arrhythmia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572154550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67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Medtronic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Mirro D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 err="1">
                          <a:effectLst/>
                        </a:rPr>
                        <a:t>percentage</a:t>
                      </a:r>
                      <a:r>
                        <a:rPr lang="de-DE" sz="1200" u="none" strike="noStrike" dirty="0">
                          <a:effectLst/>
                        </a:rPr>
                        <a:t> of pacing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734252997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68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control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3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Medtronic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Serena Quad CRT-P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51590282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69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Biotronik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Ecuro D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 err="1">
                          <a:effectLst/>
                        </a:rPr>
                        <a:t>percentage</a:t>
                      </a:r>
                      <a:r>
                        <a:rPr lang="de-DE" sz="1200" u="none" strike="noStrike" dirty="0">
                          <a:effectLst/>
                        </a:rPr>
                        <a:t> of pacing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213464276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7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Medtronic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Sensia S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981547903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7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Biotronik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Iforia 5 VR-T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 err="1">
                          <a:effectLst/>
                        </a:rPr>
                        <a:t>percentage</a:t>
                      </a:r>
                      <a:r>
                        <a:rPr lang="de-DE" sz="1200" u="none" strike="noStrike" dirty="0">
                          <a:effectLst/>
                        </a:rPr>
                        <a:t> of pacing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976312017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7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Medtronic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Ensura DR MRI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</a:rPr>
                        <a:t>arrhythmia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430541146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73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Microport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Teo D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 err="1">
                          <a:effectLst/>
                        </a:rPr>
                        <a:t>percentage</a:t>
                      </a:r>
                      <a:r>
                        <a:rPr lang="de-DE" sz="1200" u="none" strike="noStrike" dirty="0">
                          <a:effectLst/>
                        </a:rPr>
                        <a:t> of pacing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527378862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74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St. Jude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Ellipse D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additional diagnostics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58970116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75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St. Jude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Integrity D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616968046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76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control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Medtronic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Adapta D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641067317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77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3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Boston Scientific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Charisma X4 CRT-D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994041076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78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Medtronic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Relia S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031100261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79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3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Medtronic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Viva XT CRT-D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 err="1">
                          <a:effectLst/>
                        </a:rPr>
                        <a:t>percentage</a:t>
                      </a:r>
                      <a:r>
                        <a:rPr lang="de-DE" sz="1200" u="none" strike="noStrike" dirty="0">
                          <a:effectLst/>
                        </a:rPr>
                        <a:t> of pacing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195010733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8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Biotronik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Ecuro D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 err="1">
                          <a:effectLst/>
                        </a:rPr>
                        <a:t>percentage</a:t>
                      </a:r>
                      <a:r>
                        <a:rPr lang="de-DE" sz="1200" u="none" strike="noStrike" dirty="0">
                          <a:effectLst/>
                        </a:rPr>
                        <a:t> of pacing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190022486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8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Biotronik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Ecuro D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 err="1">
                          <a:effectLst/>
                        </a:rPr>
                        <a:t>percentage</a:t>
                      </a:r>
                      <a:r>
                        <a:rPr lang="de-DE" sz="1200" u="none" strike="noStrike" dirty="0">
                          <a:effectLst/>
                        </a:rPr>
                        <a:t> of pacing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358230457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8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Medtronic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Attesta D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366166933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83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3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Medtronic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Solara CRT-P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 err="1">
                          <a:effectLst/>
                        </a:rPr>
                        <a:t>percentage</a:t>
                      </a:r>
                      <a:r>
                        <a:rPr lang="de-DE" sz="1200" u="none" strike="noStrike" dirty="0">
                          <a:effectLst/>
                        </a:rPr>
                        <a:t> of pacing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628023618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84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Boston Scientific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Inogen ICD 2K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 err="1">
                          <a:effectLst/>
                        </a:rPr>
                        <a:t>sensing</a:t>
                      </a:r>
                      <a:r>
                        <a:rPr lang="de-DE" sz="1200" u="none" strike="noStrike" dirty="0">
                          <a:effectLst/>
                        </a:rPr>
                        <a:t> trends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903163897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85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Medtronic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Sensia D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76433504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86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2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Medtronic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Sensia DR 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047122471"/>
                  </a:ext>
                </a:extLst>
              </a:tr>
              <a:tr h="370323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87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 err="1" smtClean="0">
                          <a:effectLst/>
                        </a:rPr>
                        <a:t>unknown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11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200" u="none" strike="noStrike" dirty="0" err="1" smtClean="0">
                          <a:effectLst/>
                        </a:rPr>
                        <a:t>unknown</a:t>
                      </a:r>
                      <a:endParaRPr lang="de-DE" sz="1200" b="0" i="0" u="none" strike="noStrike" dirty="0" smtClean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</a:rPr>
                        <a:t>0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</a:rPr>
                        <a:t>0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383154141"/>
                  </a:ext>
                </a:extLst>
              </a:tr>
            </a:tbl>
          </a:graphicData>
        </a:graphic>
      </p:graphicFrame>
      <p:sp>
        <p:nvSpPr>
          <p:cNvPr id="2" name="Rechteck 1"/>
          <p:cNvSpPr/>
          <p:nvPr/>
        </p:nvSpPr>
        <p:spPr>
          <a:xfrm>
            <a:off x="0" y="0"/>
            <a:ext cx="1230055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Supplemental table 1: </a:t>
            </a:r>
          </a:p>
          <a:p>
            <a:r>
              <a:rPr lang="en-US" dirty="0"/>
              <a:t>Characteristics of all 87 CIED as well as results of the interrogation are depicted. </a:t>
            </a:r>
          </a:p>
        </p:txBody>
      </p:sp>
    </p:spTree>
    <p:extLst>
      <p:ext uri="{BB962C8B-B14F-4D97-AF65-F5344CB8AC3E}">
        <p14:creationId xmlns:p14="http://schemas.microsoft.com/office/powerpoint/2010/main" val="5404057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29</Words>
  <Application>Microsoft Office PowerPoint</Application>
  <PresentationFormat>Breitbild</PresentationFormat>
  <Paragraphs>849</Paragraphs>
  <Slides>3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</vt:lpstr>
      <vt:lpstr>PowerPoint-Präsentation</vt:lpstr>
      <vt:lpstr>PowerPoint-Präsentation</vt:lpstr>
      <vt:lpstr>PowerPoint-Präsentation</vt:lpstr>
    </vt:vector>
  </TitlesOfParts>
  <Company>Klinikum der Universitaet Muench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Lackermair, Korbinian Dr.</dc:creator>
  <cp:lastModifiedBy>Lackermair, Korbinian Dr.</cp:lastModifiedBy>
  <cp:revision>3</cp:revision>
  <dcterms:created xsi:type="dcterms:W3CDTF">2021-08-31T05:54:41Z</dcterms:created>
  <dcterms:modified xsi:type="dcterms:W3CDTF">2021-11-12T14:14:21Z</dcterms:modified>
</cp:coreProperties>
</file>